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8AE370-C1B9-453E-B077-45632A6523D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4F643C-D5A2-4E98-BCEC-E063893CC55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8BA89B-67AD-404D-A02F-952FD894B9A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ED5ED2-85C0-4B20-9FF5-A097B19EF14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A4CAAC-D936-47AF-A64E-57B64CA5DC7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972818-A14E-4B37-95FD-CC4235B3806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571249-74DC-4BF2-B29C-A01C0B3D31D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73118B-2FAD-4E4C-90FB-CEE65B0B08B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25650F-C184-4342-B111-08D83212EFB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499346-024F-4EF4-9955-4E298AA9F36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547B8D-61DE-4CFF-9E8D-01F69A7B94D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C6E702-223E-40FE-A6DA-64C2B60399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506B0D76-FB9E-461D-A00B-E884ABB40029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E27F97EF-51AF-4AF1-9833-31DEFDDB2E87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17" descr="BT pie chart"/>
          <p:cNvPicPr/>
          <p:nvPr/>
        </p:nvPicPr>
        <p:blipFill>
          <a:blip r:embed="rId1"/>
          <a:stretch/>
        </p:blipFill>
        <p:spPr>
          <a:xfrm>
            <a:off x="-96840" y="990720"/>
            <a:ext cx="6649920" cy="5105160"/>
          </a:xfrm>
          <a:prstGeom prst="rect">
            <a:avLst/>
          </a:prstGeom>
          <a:ln w="0">
            <a:noFill/>
          </a:ln>
        </p:spPr>
      </p:pic>
      <p:sp>
        <p:nvSpPr>
          <p:cNvPr id="42" name="Text Box 14"/>
          <p:cNvSpPr/>
          <p:nvPr/>
        </p:nvSpPr>
        <p:spPr>
          <a:xfrm>
            <a:off x="5936040" y="838080"/>
            <a:ext cx="2652120" cy="5576040"/>
          </a:xfrm>
          <a:prstGeom prst="rect">
            <a:avLst/>
          </a:prstGeom>
          <a:noFill/>
          <a:ln w="0">
            <a:noFill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285840" indent="-246240">
              <a:tabLst>
                <a:tab algn="l" pos="0"/>
                <a:tab algn="l" pos="3657600"/>
                <a:tab algn="l" pos="73152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Bacillus cereu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285840" indent="-246240">
              <a:tabLst>
                <a:tab algn="l" pos="0"/>
                <a:tab algn="l" pos="3657600"/>
                <a:tab algn="l" pos="73152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Brucella melitensi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285840" indent="-246240">
              <a:tabLst>
                <a:tab algn="l" pos="0"/>
                <a:tab algn="l" pos="3657600"/>
                <a:tab algn="l" pos="73152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.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Brucella abortu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285840" indent="-246240">
              <a:tabLst>
                <a:tab algn="l" pos="0"/>
                <a:tab algn="l" pos="3657600"/>
                <a:tab algn="l" pos="73152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.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Burkholderia malle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285840" indent="-246240">
              <a:tabLst>
                <a:tab algn="l" pos="0"/>
                <a:tab algn="l" pos="3657600"/>
                <a:tab algn="l" pos="73152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Burkholderia pseudomalle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285840" indent="-246240">
              <a:tabLst>
                <a:tab algn="l" pos="0"/>
                <a:tab algn="l" pos="3657600"/>
                <a:tab algn="l" pos="73152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Clostridium perfringen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285840" indent="-246240">
              <a:tabLst>
                <a:tab algn="l" pos="0"/>
                <a:tab algn="l" pos="3657600"/>
                <a:tab algn="l" pos="73152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Chlamydia psittac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285840" indent="-246240">
              <a:tabLst>
                <a:tab algn="l" pos="0"/>
                <a:tab algn="l" pos="3657600"/>
                <a:tab algn="l" pos="73152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8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Coxiella burneti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285840" indent="-246240">
              <a:tabLst>
                <a:tab algn="l" pos="0"/>
                <a:tab algn="l" pos="3657600"/>
                <a:tab algn="l" pos="73152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9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Cryptosporidium parvu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285840" indent="-246240">
              <a:tabLst>
                <a:tab algn="l" pos="0"/>
                <a:tab algn="l" pos="3657600"/>
                <a:tab algn="l" pos="73152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Rickettsia prowazeki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285840" indent="-246240">
              <a:tabLst>
                <a:tab algn="l" pos="0"/>
                <a:tab algn="l" pos="3657600"/>
                <a:tab algn="l" pos="73152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1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Rickettsia typh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285840" indent="-246240">
              <a:tabLst>
                <a:tab algn="l" pos="0"/>
                <a:tab algn="l" pos="3657600"/>
                <a:tab algn="l" pos="73152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2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Rickettsia tsutsugamush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285840" indent="-246240">
              <a:tabLst>
                <a:tab algn="l" pos="0"/>
                <a:tab algn="l" pos="3657600"/>
                <a:tab algn="l" pos="73152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3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Bartonella quintana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285840" indent="-246240">
              <a:tabLst>
                <a:tab algn="l" pos="0"/>
                <a:tab algn="l" pos="3657600"/>
                <a:tab algn="l" pos="73152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4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Campylobacter jejuni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285840" indent="-246240">
              <a:tabLst>
                <a:tab algn="l" pos="0"/>
                <a:tab algn="l" pos="3657600"/>
                <a:tab algn="l" pos="73152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5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Salmonella typh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285840" indent="-246240">
              <a:tabLst>
                <a:tab algn="l" pos="0"/>
                <a:tab algn="l" pos="3657600"/>
                <a:tab algn="l" pos="73152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6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Salmonella enteric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285840" indent="-246240">
              <a:tabLst>
                <a:tab algn="l" pos="0"/>
                <a:tab algn="l" pos="3657600"/>
                <a:tab algn="l" pos="73152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7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Leptospira interrogans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285840" indent="-246240">
              <a:tabLst>
                <a:tab algn="l" pos="0"/>
                <a:tab algn="l" pos="3657600"/>
                <a:tab algn="l" pos="73152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8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Mycobacterium tuberculosis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285840" indent="-246240">
              <a:tabLst>
                <a:tab algn="l" pos="0"/>
                <a:tab algn="l" pos="3657600"/>
                <a:tab algn="l" pos="73152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9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eoul virus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285840" indent="-246240">
              <a:tabLst>
                <a:tab algn="l" pos="0"/>
                <a:tab algn="l" pos="3657600"/>
                <a:tab algn="l" pos="73152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0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oscana virus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285840" indent="-246240">
              <a:tabLst>
                <a:tab algn="l" pos="0"/>
                <a:tab algn="l" pos="3657600"/>
                <a:tab algn="l" pos="73152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1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unta Toro virus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285840" indent="-246240">
              <a:tabLst>
                <a:tab algn="l" pos="0"/>
                <a:tab algn="l" pos="3657600"/>
                <a:tab algn="l" pos="73152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2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in Nombre virus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285840" indent="-246240">
              <a:tabLst>
                <a:tab algn="l" pos="0"/>
                <a:tab algn="l" pos="3657600"/>
                <a:tab algn="l" pos="73152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3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'nyong-nyong virus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285840" indent="-246240">
              <a:tabLst>
                <a:tab algn="l" pos="0"/>
                <a:tab algn="l" pos="3657600"/>
                <a:tab algn="l" pos="73152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4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ariola major virus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285840" indent="-246240">
              <a:tabLst>
                <a:tab algn="l" pos="0"/>
                <a:tab algn="l" pos="3657600"/>
                <a:tab algn="l" pos="73152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5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uman herpesvirus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285840" indent="-246240">
              <a:tabLst>
                <a:tab algn="l" pos="0"/>
                <a:tab algn="l" pos="3657600"/>
                <a:tab algn="l" pos="73152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6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oot and mouth disease virus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285840" indent="-246240">
              <a:tabLst>
                <a:tab algn="l" pos="0"/>
                <a:tab algn="l" pos="3657600"/>
                <a:tab algn="l" pos="73152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7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orbilliviru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285840" indent="-246240">
              <a:tabLst>
                <a:tab algn="l" pos="0"/>
                <a:tab algn="l" pos="3657600"/>
                <a:tab algn="l" pos="73152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8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Clostridium perfringens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285840" indent="-246240">
              <a:tabLst>
                <a:tab algn="l" pos="0"/>
                <a:tab algn="l" pos="3657600"/>
                <a:tab algn="l" pos="73152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9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Ricinus communis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285840" indent="-246240">
              <a:tabLst>
                <a:tab algn="l" pos="0"/>
                <a:tab algn="l" pos="3657600"/>
                <a:tab algn="l" pos="73152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0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Staphylococcus aureus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285840" indent="-246240">
              <a:tabLst>
                <a:tab algn="l" pos="0"/>
                <a:tab algn="l" pos="3657600"/>
                <a:tab algn="l" pos="73152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1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Clostridium tetani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285840" indent="-246240">
              <a:tabLst>
                <a:tab algn="l" pos="0"/>
                <a:tab algn="l" pos="3657600"/>
                <a:tab algn="l" pos="73152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2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Escherichia coli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157:H7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285840" indent="-246240">
              <a:tabLst>
                <a:tab algn="l" pos="0"/>
                <a:tab algn="l" pos="3657600"/>
                <a:tab algn="l" pos="73152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3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Vibrio cholerae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285840" indent="-246240">
              <a:tabLst>
                <a:tab algn="l" pos="0"/>
                <a:tab algn="l" pos="3657600"/>
                <a:tab algn="l" pos="73152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4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Arabidopsis thaliana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IM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285840" indent="-246240">
              <a:tabLst>
                <a:tab algn="l" pos="0"/>
                <a:tab algn="l" pos="3657600"/>
                <a:tab algn="l" pos="73152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5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Arabidopsis thaliana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AC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285840" indent="-246240">
              <a:tabLst>
                <a:tab algn="l" pos="0"/>
                <a:tab algn="l" pos="3657600"/>
                <a:tab algn="l" pos="73152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6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ntrol sequenc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Box 5"/>
          <p:cNvSpPr/>
          <p:nvPr/>
        </p:nvSpPr>
        <p:spPr>
          <a:xfrm>
            <a:off x="762480" y="272880"/>
            <a:ext cx="5904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Supporting Figure S1.  Space on the RPM-TEI allocated for individual organisms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7"/>
          <p:cNvSpPr/>
          <p:nvPr/>
        </p:nvSpPr>
        <p:spPr>
          <a:xfrm>
            <a:off x="304920" y="6095880"/>
            <a:ext cx="43434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RPM-TEI contains a total of  936,000 eight micron features, which corresponds to a resequencing capacity of of 117, 000 base pair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3-20T14:46:43Z</dcterms:created>
  <dc:creator>Tomasz Leski</dc:creator>
  <dc:description/>
  <dc:language>en-US</dc:language>
  <cp:lastModifiedBy>Tomasz Leski</cp:lastModifiedBy>
  <cp:lastPrinted>2009-03-20T14:53:19Z</cp:lastPrinted>
  <dcterms:modified xsi:type="dcterms:W3CDTF">2009-07-22T19:08:48Z</dcterms:modified>
  <cp:revision>9</cp:revision>
  <dc:subject/>
  <dc:title>Slide 1</dc:title>
</cp:coreProperties>
</file>